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0" r:id="rId2"/>
    <p:sldId id="262" r:id="rId3"/>
    <p:sldId id="263" r:id="rId4"/>
    <p:sldId id="264" r:id="rId5"/>
    <p:sldId id="257" r:id="rId6"/>
    <p:sldId id="261" r:id="rId7"/>
    <p:sldId id="259" r:id="rId8"/>
  </p:sldIdLst>
  <p:sldSz cx="9144000" cy="6858000" type="screen4x3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1644" y="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2863" y="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6D754B-161D-4AD6-91B1-232F37E44566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704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038" y="4781550"/>
            <a:ext cx="5441950" cy="39116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610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2863" y="943610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B819C0-8937-4D01-BBED-B4E295360E1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716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B519A-47EB-4843-A428-CF2403DA5376}" type="datetimeFigureOut">
              <a:rPr lang="ko-KR" altLang="en-US" smtClean="0"/>
              <a:pPr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9FDDB-DC27-4AE4-911F-84B0AA4C71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07504" y="181470"/>
            <a:ext cx="460331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Table 1. The combination of crude components of </a:t>
            </a:r>
            <a:r>
              <a:rPr kumimoji="1" lang="en-US" altLang="ko-KR" sz="14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CRT</a:t>
            </a:r>
            <a:endParaRPr kumimoji="1" lang="en-US" altLang="ko-K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5613198"/>
              </p:ext>
            </p:extLst>
          </p:nvPr>
        </p:nvGraphicFramePr>
        <p:xfrm>
          <a:off x="323528" y="908720"/>
          <a:ext cx="8229600" cy="39604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153583"/>
                <a:gridCol w="1134039"/>
                <a:gridCol w="1907621"/>
                <a:gridCol w="2034357"/>
              </a:tblGrid>
              <a:tr h="39604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tin name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 (g)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 of purchase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hedrae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ba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25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oniae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dix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2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iseong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Kore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isandrae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uctus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2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cheok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Kore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nelliae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uber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2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iasari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dix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ingiberis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izoma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udus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lsan, Kore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namomi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mulus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etnam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marL="90170" algn="l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ae</a:t>
                      </a:r>
                      <a:r>
                        <a:rPr lang="en-US" sz="1200" b="0" i="1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dix et </a:t>
                      </a:r>
                      <a:r>
                        <a:rPr lang="en-US" sz="1200" b="0" i="1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izoma</a:t>
                      </a:r>
                      <a:endParaRPr lang="ko-KR" sz="1000" b="0" i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wangmyungdang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a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96044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4770" marR="64770" marT="17780" marB="1778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20556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323528" y="260648"/>
            <a:ext cx="500758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Table 2. Calibration curves of eight marker components (n=3). </a:t>
            </a:r>
            <a:endParaRPr kumimoji="1" lang="en-US" altLang="ko-K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2957015"/>
              </p:ext>
            </p:extLst>
          </p:nvPr>
        </p:nvGraphicFramePr>
        <p:xfrm>
          <a:off x="307544" y="960511"/>
          <a:ext cx="8496944" cy="33985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04107"/>
                <a:gridCol w="1639910"/>
                <a:gridCol w="3007918"/>
                <a:gridCol w="1645009"/>
              </a:tblGrid>
              <a:tr h="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nent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ar range (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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mL)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ression </a:t>
                      </a: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quation</a:t>
                      </a:r>
                      <a:r>
                        <a:rPr lang="en-US" sz="1200" kern="100" baseline="300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(r</a:t>
                      </a:r>
                      <a:r>
                        <a:rPr lang="en-US" sz="1200" kern="1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biflorin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1,446.68x – 9,521.54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8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oniflorin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00.00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1,710.55x – 11,754.55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0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quiritin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5,742.58x – 4,464.81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9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5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44,991.78x – 11,749.86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7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namic acid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5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81,948.89x – 14,191.11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9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namaldehyde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5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2,2613.12x – 20,278.53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9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in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5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1,615.46x – 2,971.52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6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909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izandrin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 5</a:t>
                      </a: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= 17,962.63x – 3,512.27</a:t>
                      </a:r>
                      <a:endParaRPr lang="ko-KR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95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직사각형 5"/>
          <p:cNvSpPr/>
          <p:nvPr/>
        </p:nvSpPr>
        <p:spPr>
          <a:xfrm>
            <a:off x="323528" y="4509120"/>
            <a:ext cx="417646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0"/>
              </a:spcAft>
            </a:pPr>
            <a:r>
              <a:rPr lang="en-US" altLang="ko-KR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a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y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 means peak area (</a:t>
            </a:r>
            <a:r>
              <a:rPr lang="en-US" altLang="ko-K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mAU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).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x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 means concentration (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g/mL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).</a:t>
            </a:r>
            <a:endParaRPr lang="ko-KR" altLang="ko-KR" sz="1200" dirty="0">
              <a:solidFill>
                <a:srgbClr val="000000"/>
              </a:solidFill>
              <a:effectLst/>
              <a:latin typeface="바탕" panose="02030600000101010101" pitchFamily="18" charset="-127"/>
              <a:ea typeface="바탕" panose="02030600000101010101" pitchFamily="18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330243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23528" y="260648"/>
            <a:ext cx="532350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Table 3. Contents of eight components</a:t>
            </a:r>
            <a:r>
              <a:rPr kumimoji="1" lang="en-US" altLang="ko-KR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in the SCRT by HPLC (n=3).</a:t>
            </a:r>
            <a:endParaRPr kumimoji="1" lang="en-US" altLang="ko-K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5299121"/>
              </p:ext>
            </p:extLst>
          </p:nvPr>
        </p:nvGraphicFramePr>
        <p:xfrm>
          <a:off x="251520" y="1124744"/>
          <a:ext cx="8640960" cy="321588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432190"/>
                <a:gridCol w="2053092"/>
                <a:gridCol w="1444768"/>
                <a:gridCol w="1710910"/>
              </a:tblGrid>
              <a:tr h="432048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(mg/g)</a:t>
                      </a:r>
                      <a:endParaRPr lang="ko-KR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lang="ko-KR" sz="14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D (%)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biflor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eoniflor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0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quirit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9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namic acid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nnamaldehyde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yrrhiz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noFill/>
                  </a:tcPr>
                </a:tc>
              </a:tr>
              <a:tr h="347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izandrin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</a:t>
                      </a:r>
                      <a:endParaRPr lang="ko-KR" sz="1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ko-KR" sz="1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바탕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46755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0406596"/>
              </p:ext>
            </p:extLst>
          </p:nvPr>
        </p:nvGraphicFramePr>
        <p:xfrm>
          <a:off x="255852" y="349378"/>
          <a:ext cx="8348597" cy="5815018"/>
        </p:xfrm>
        <a:graphic>
          <a:graphicData uri="http://schemas.openxmlformats.org/drawingml/2006/table">
            <a:tbl>
              <a:tblPr/>
              <a:tblGrid>
                <a:gridCol w="1873565"/>
                <a:gridCol w="731052"/>
                <a:gridCol w="1253232"/>
                <a:gridCol w="1148796"/>
                <a:gridCol w="1357668"/>
                <a:gridCol w="1148796"/>
                <a:gridCol w="835488"/>
              </a:tblGrid>
              <a:tr h="71073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Nominal</a:t>
                      </a:r>
                      <a:r>
                        <a:rPr lang="en-US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conc. of  SCRT (</a:t>
                      </a:r>
                      <a:r>
                        <a:rPr lang="el-GR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μ</a:t>
                      </a:r>
                      <a:r>
                        <a:rPr lang="en-US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g/</a:t>
                      </a:r>
                      <a:r>
                        <a:rPr lang="en-US" sz="1100" kern="100" baseline="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L</a:t>
                      </a:r>
                      <a:r>
                        <a:rPr lang="en-US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)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S9 mix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Time hours</a:t>
                      </a:r>
                      <a:r>
                        <a:rPr lang="en-US" altLang="ko-KR" sz="1100" kern="1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a)</a:t>
                      </a:r>
                      <a:endParaRPr lang="ko-KR" sz="1100" kern="100" baseline="300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total</a:t>
                      </a:r>
                      <a:r>
                        <a:rPr lang="en-US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aberrant metaphases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total</a:t>
                      </a:r>
                      <a:r>
                        <a:rPr lang="en-US" altLang="ko-KR" sz="11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aberrations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of PP+ER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Relative cell counts (%)</a:t>
                      </a:r>
                      <a:endParaRPr lang="ko-KR" sz="11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6 h treatment</a:t>
                      </a:r>
                      <a:r>
                        <a:rPr lang="en-US" sz="1000" kern="100" baseline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 (+S9)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Vehicle control</a:t>
                      </a: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0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altLang="ko-KR" sz="10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 + 0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 counted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7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/0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4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1.0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.5/2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4.0 + 0.0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2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.5/5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.0/7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8.5 + 0.0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74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Positive</a:t>
                      </a: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ntrol</a:t>
                      </a:r>
                    </a:p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(</a:t>
                      </a: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CPA 6)</a:t>
                      </a: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2.0/12.0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sz="10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5.5/15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.0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6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6 h treatment</a:t>
                      </a:r>
                      <a:r>
                        <a:rPr lang="en-US" altLang="ko-KR" sz="1000" kern="100" baseline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 (-S9)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Vehicle control</a:t>
                      </a:r>
                      <a:endParaRPr lang="ko-KR" alt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/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/0.0</a:t>
                      </a: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.0 + 0.0</a:t>
                      </a: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3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79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8.5/8.0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*</a:t>
                      </a: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3.0/12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.5 + 0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</a:t>
                      </a: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3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</a:t>
                      </a:r>
                      <a:r>
                        <a:rPr lang="en-US" altLang="ko-KR" sz="1000" kern="1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unted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Positive</a:t>
                      </a: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ntrol</a:t>
                      </a:r>
                    </a:p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(</a:t>
                      </a: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EMS 800)</a:t>
                      </a: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8.5/18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*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1.0/31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7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 h treatment (-S9)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Vehicle control</a:t>
                      </a:r>
                      <a:endParaRPr lang="ko-KR" alt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5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5 + 0.0</a:t>
                      </a:r>
                      <a:endParaRPr lang="ko-KR" altLang="ko-KR" sz="10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3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1.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0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.5/5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.5/9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.5 + 0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</a:t>
                      </a: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9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5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 smtClean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0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</a:t>
                      </a:r>
                      <a:r>
                        <a:rPr lang="en-US" altLang="ko-KR" sz="1000" kern="1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unted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ko-KR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9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22-2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0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 counted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ko-KR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2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Positive</a:t>
                      </a: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ntrol</a:t>
                      </a:r>
                    </a:p>
                    <a:p>
                      <a:pPr algn="ctr" latinLnBrk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baseline="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(</a:t>
                      </a:r>
                      <a:r>
                        <a:rPr lang="en-US" altLang="ko-KR" sz="1000" kern="100" dirty="0" smtClean="0">
                          <a:solidFill>
                            <a:srgbClr val="0000CC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EMS 600)</a:t>
                      </a:r>
                      <a:endParaRPr lang="ko-KR" sz="10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3.5/23.5</a:t>
                      </a:r>
                      <a:r>
                        <a:rPr lang="en-US" altLang="ko-KR" sz="10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sz="10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7.0/36.5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7</a:t>
                      </a:r>
                      <a:endParaRPr lang="ko-KR" sz="10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2529" name="Rectangle 1"/>
          <p:cNvSpPr>
            <a:spLocks noChangeArrowheads="1"/>
          </p:cNvSpPr>
          <p:nvPr/>
        </p:nvSpPr>
        <p:spPr bwMode="auto">
          <a:xfrm>
            <a:off x="107504" y="22039"/>
            <a:ext cx="57642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indent="7620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Table </a:t>
            </a:r>
            <a:r>
              <a:rPr kumimoji="1" lang="en-US" altLang="ko-KR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4</a:t>
            </a: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. Chromosome aberration assay and relative cell counts of </a:t>
            </a:r>
            <a:r>
              <a:rPr kumimoji="1" lang="en-US" altLang="ko-KR" sz="14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CRT.</a:t>
            </a:r>
            <a:endParaRPr kumimoji="1" lang="en-US" altLang="ko-KR" sz="1400" b="1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6382087"/>
            <a:ext cx="4974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aseline="300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r>
              <a:rPr lang="en-US" altLang="ko-KR" sz="12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ko-KR" sz="1200" baseline="300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**</a:t>
            </a:r>
            <a:r>
              <a:rPr lang="en-US" altLang="ko-KR" sz="12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ignificantly different from the control at </a:t>
            </a:r>
            <a:r>
              <a:rPr lang="en-US" altLang="ko-KR" sz="12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P&lt;0.05 and P&lt;0.01, respectively</a:t>
            </a:r>
            <a:endParaRPr lang="ko-KR" altLang="en-US" sz="1200" dirty="0">
              <a:solidFill>
                <a:srgbClr val="0000CC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364088" y="6382087"/>
            <a:ext cx="2592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 a)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Treatment time-recovery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time  </a:t>
            </a:r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4115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692640"/>
              </p:ext>
            </p:extLst>
          </p:nvPr>
        </p:nvGraphicFramePr>
        <p:xfrm>
          <a:off x="251517" y="476672"/>
          <a:ext cx="8640961" cy="5781480"/>
        </p:xfrm>
        <a:graphic>
          <a:graphicData uri="http://schemas.openxmlformats.org/drawingml/2006/table">
            <a:tbl>
              <a:tblPr/>
              <a:tblGrid>
                <a:gridCol w="1522537"/>
                <a:gridCol w="493690"/>
                <a:gridCol w="1028848"/>
                <a:gridCol w="1275405"/>
                <a:gridCol w="1440160"/>
                <a:gridCol w="1368152"/>
                <a:gridCol w="1512169"/>
              </a:tblGrid>
              <a:tr h="71073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Nominal</a:t>
                      </a:r>
                      <a:r>
                        <a:rPr lang="en-US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conc. of  SCRT (</a:t>
                      </a:r>
                      <a:r>
                        <a:rPr lang="el-GR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μ</a:t>
                      </a:r>
                      <a:r>
                        <a:rPr lang="en-US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g/</a:t>
                      </a:r>
                      <a:r>
                        <a:rPr lang="en-US" sz="1200" kern="100" baseline="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L</a:t>
                      </a:r>
                      <a:r>
                        <a:rPr lang="en-US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)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S9 mix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Time hours</a:t>
                      </a:r>
                      <a:r>
                        <a:rPr lang="en-US" altLang="ko-KR" sz="1200" kern="1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a)</a:t>
                      </a:r>
                      <a:endParaRPr lang="ko-KR" sz="1200" kern="100" baseline="300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total</a:t>
                      </a:r>
                      <a:r>
                        <a:rPr lang="en-US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aberrant metaphases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total</a:t>
                      </a:r>
                      <a:r>
                        <a:rPr lang="en-US" altLang="ko-KR" sz="1200" kern="100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 aberrations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Mean of PP+ER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돋움"/>
                          <a:cs typeface="Times New Roman" pitchFamily="18" charset="0"/>
                        </a:rPr>
                        <a:t>Relative cell counts (%)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6 h treatment</a:t>
                      </a:r>
                      <a:r>
                        <a:rPr lang="en-US" sz="1200" kern="100" baseline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 (+S9)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2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altLang="ko-KR" sz="12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 + 0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 counted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7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/0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4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1.0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.5/2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4.0 + 0.0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2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.5/5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.0/7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8.5 + 0.0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74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CPA 6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+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2.0/12.0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sz="12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5.5/15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.0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6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6 h treatment</a:t>
                      </a:r>
                      <a:r>
                        <a:rPr lang="en-US" altLang="ko-KR" sz="1200" kern="100" baseline="0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돋움"/>
                          <a:cs typeface="Times New Roman" panose="02020603050405020304" pitchFamily="18" charset="0"/>
                        </a:rPr>
                        <a:t> (-S9)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/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5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.0/0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0/0.0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1.0 + 0.0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3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79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8.5/8.0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*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3.0/12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.5 + 0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3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6-18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</a:t>
                      </a:r>
                      <a:r>
                        <a:rPr lang="en-US" altLang="ko-KR" sz="1200" kern="1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unted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EMS 8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-1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8.5/18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**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1.0/31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7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691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 h treatment (-S9)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dirty="0">
                        <a:solidFill>
                          <a:srgbClr val="0000CC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0.5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5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0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5 + 0.0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3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/1.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5/1.5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.5/5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.5/9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.5 + 0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</a:t>
                      </a: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9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5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 smtClean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endParaRPr lang="ko-KR" sz="12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</a:t>
                      </a:r>
                      <a:r>
                        <a:rPr lang="en-US" altLang="ko-KR" sz="1200" kern="1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 counted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9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000</a:t>
                      </a:r>
                      <a:endParaRPr 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rgbClr val="000000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22-2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ko-KR" sz="1200" kern="100" baseline="300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Not counted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2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4667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EMS 600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-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2-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23.5/23.5</a:t>
                      </a:r>
                      <a:r>
                        <a:rPr lang="en-US" altLang="ko-KR" sz="1200" kern="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**</a:t>
                      </a:r>
                      <a:endParaRPr lang="ko-KR" sz="1200" kern="100" baseline="300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37.0/36.5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1.0 + 0.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7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2529" name="Rectangle 1"/>
          <p:cNvSpPr>
            <a:spLocks noChangeArrowheads="1"/>
          </p:cNvSpPr>
          <p:nvPr/>
        </p:nvSpPr>
        <p:spPr bwMode="auto">
          <a:xfrm>
            <a:off x="107504" y="22039"/>
            <a:ext cx="57642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indent="7620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Table </a:t>
            </a:r>
            <a:r>
              <a:rPr kumimoji="1" lang="en-US" altLang="ko-KR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4</a:t>
            </a: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. Chromosome aberration assay and relative cell counts of </a:t>
            </a:r>
            <a:r>
              <a:rPr kumimoji="1" lang="en-US" altLang="ko-KR" sz="14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CRT.</a:t>
            </a:r>
            <a:endParaRPr kumimoji="1" lang="en-US" altLang="ko-KR" sz="1400" b="1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91161" y="6268133"/>
            <a:ext cx="3376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**Significantly different from the control at P&lt;0.01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91161" y="6453336"/>
            <a:ext cx="55446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 a)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Treatment time-recovery time 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451900"/>
            <a:ext cx="89644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indent="7620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Table </a:t>
            </a:r>
            <a:r>
              <a:rPr kumimoji="1" lang="en-US" altLang="ko-KR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5. Body weight changes of Micronucleus </a:t>
            </a:r>
            <a:r>
              <a:rPr kumimoji="1" lang="en-US" altLang="ko-KR" sz="14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test in mice following </a:t>
            </a:r>
            <a:r>
              <a:rPr kumimoji="1" lang="en-US" altLang="ko-KR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administration of</a:t>
            </a:r>
            <a:r>
              <a:rPr kumimoji="1" lang="ko-KR" altLang="en-US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 </a:t>
            </a:r>
            <a:r>
              <a:rPr kumimoji="1" lang="en-US" altLang="ko-KR" sz="14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CRT</a:t>
            </a:r>
            <a:endParaRPr kumimoji="1" lang="en-US" altLang="ko-KR" sz="1400" b="1" baseline="30000" dirty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1886611"/>
              </p:ext>
            </p:extLst>
          </p:nvPr>
        </p:nvGraphicFramePr>
        <p:xfrm>
          <a:off x="179512" y="1052736"/>
          <a:ext cx="8784976" cy="23174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158066"/>
                <a:gridCol w="1432315"/>
                <a:gridCol w="1375040"/>
                <a:gridCol w="1298649"/>
                <a:gridCol w="1145866"/>
                <a:gridCol w="1375040"/>
              </a:tblGrid>
              <a:tr h="152845">
                <a:tc>
                  <a:txBody>
                    <a:bodyPr/>
                    <a:lstStyle/>
                    <a:p>
                      <a:pPr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            Group </a:t>
                      </a: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rgbClr val="0000CC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ehicle control</a:t>
                      </a:r>
                    </a:p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rgbClr val="0000CC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DW)</a:t>
                      </a:r>
                      <a:endParaRPr lang="ko-KR" sz="1200" b="1" kern="100" dirty="0">
                        <a:solidFill>
                          <a:srgbClr val="0000CC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rgbClr val="0000CC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control</a:t>
                      </a:r>
                    </a:p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rgbClr val="0000CC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CPA)</a:t>
                      </a:r>
                      <a:endParaRPr lang="ko-KR" sz="1200" b="1" kern="100" dirty="0">
                        <a:solidFill>
                          <a:srgbClr val="0000CC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2845">
                <a:tc>
                  <a:txBody>
                    <a:bodyPr/>
                    <a:lstStyle/>
                    <a:p>
                      <a:pPr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        Dose</a:t>
                      </a:r>
                      <a:r>
                        <a:rPr lang="en-US" sz="1200" b="1" kern="1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(mg/kg)</a:t>
                      </a:r>
                      <a:endParaRPr lang="en-US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0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00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23808">
                <a:tc>
                  <a:txBody>
                    <a:bodyPr/>
                    <a:lstStyle/>
                    <a:p>
                      <a:pPr marL="180340"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ay 1 (Mean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± S.D)</a:t>
                      </a:r>
                      <a:endParaRPr lang="ko-KR" altLang="ko-KR" sz="1200" b="1" i="0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3 ± 1.08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6 ± 0.8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8 ± 1.15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1 ± 0.32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.1</a:t>
                      </a:r>
                      <a:r>
                        <a:rPr lang="en-US" altLang="ko-KR" sz="12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± 0.66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68367">
                <a:tc>
                  <a:txBody>
                    <a:bodyPr/>
                    <a:lstStyle/>
                    <a:p>
                      <a:pPr marL="180340"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ay 2 (Mean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± S.D)</a:t>
                      </a:r>
                      <a:endParaRPr lang="ko-KR" altLang="ko-KR" sz="1200" b="1" i="0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3 ± 0.97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9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55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.3 ± 1.06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3.9 ± 0.61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6.1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15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68367">
                <a:tc>
                  <a:txBody>
                    <a:bodyPr/>
                    <a:lstStyle/>
                    <a:p>
                      <a:pPr marL="180340"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Day 3 (Mean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± S.D)</a:t>
                      </a:r>
                      <a:endParaRPr lang="ko-KR" altLang="ko-KR" sz="1200" b="1" i="0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6 ± 1.36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.1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59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.5 ± 0.8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.4 ± 0.5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6.0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23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51520" y="3429000"/>
            <a:ext cx="7920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PA: cyclophosphamide monohydrate, DW: distilled water</a:t>
            </a:r>
            <a:endParaRPr lang="ko-KR" altLang="en-US" sz="1200" dirty="0">
              <a:solidFill>
                <a:srgbClr val="0000CC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67092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07504" y="153888"/>
            <a:ext cx="568739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indent="7620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400" b="1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Table 6. Micronucleus</a:t>
            </a:r>
            <a:r>
              <a:rPr kumimoji="1" lang="en-US" altLang="ko-KR" sz="1400" b="1" i="0" u="none" strike="noStrike" cap="none" normalizeH="0" dirty="0" smtClean="0">
                <a:ln>
                  <a:noFill/>
                </a:ln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 test in mice following a single oral dose </a:t>
            </a:r>
            <a:r>
              <a:rPr kumimoji="1" lang="en-US" altLang="ko-KR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of</a:t>
            </a:r>
            <a:r>
              <a:rPr kumimoji="1" lang="ko-KR" altLang="en-US" sz="14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 </a:t>
            </a:r>
            <a:r>
              <a:rPr kumimoji="1" lang="en-US" altLang="ko-KR" sz="1400" b="1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CRT</a:t>
            </a:r>
            <a:endParaRPr kumimoji="1" lang="en-US" altLang="ko-KR" sz="1400" b="1" i="0" u="none" strike="noStrike" cap="none" normalizeH="0" baseline="30000" dirty="0" smtClean="0">
              <a:ln>
                <a:noFill/>
              </a:ln>
              <a:effectLst/>
              <a:latin typeface="굴림" pitchFamily="50" charset="-127"/>
              <a:ea typeface="굴림" pitchFamily="50" charset="-127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8708521"/>
              </p:ext>
            </p:extLst>
          </p:nvPr>
        </p:nvGraphicFramePr>
        <p:xfrm>
          <a:off x="323529" y="779684"/>
          <a:ext cx="8568950" cy="224609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104998"/>
                <a:gridCol w="1397094"/>
                <a:gridCol w="1341227"/>
                <a:gridCol w="1266715"/>
                <a:gridCol w="1117689"/>
                <a:gridCol w="1341227"/>
              </a:tblGrid>
              <a:tr h="152845">
                <a:tc>
                  <a:txBody>
                    <a:bodyPr/>
                    <a:lstStyle/>
                    <a:p>
                      <a:pPr algn="l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            Group </a:t>
                      </a: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ehicle control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400" b="1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맑은 고딕" pitchFamily="50" charset="-127"/>
                          <a:cs typeface="Times New Roman" pitchFamily="18" charset="0"/>
                        </a:rPr>
                        <a:t>SCRT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control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2845"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ose</a:t>
                      </a:r>
                      <a:r>
                        <a:rPr lang="en-US" sz="1200" b="1" kern="1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(mg/kg)</a:t>
                      </a:r>
                      <a:endParaRPr lang="en-US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0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00</a:t>
                      </a:r>
                      <a:endParaRPr lang="ko-KR" altLang="ko-KR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0</a:t>
                      </a:r>
                      <a:endParaRPr lang="ko-KR" sz="1200" b="1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759451">
                <a:tc>
                  <a:txBody>
                    <a:bodyPr/>
                    <a:lstStyle/>
                    <a:p>
                      <a:pPr marL="180340"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NPCE/2000PCEs</a:t>
                      </a:r>
                    </a:p>
                    <a:p>
                      <a:pPr marL="180340"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(Mean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2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± S.D)</a:t>
                      </a:r>
                      <a:endParaRPr lang="ko-KR" sz="1200" b="1" i="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67 ± 2.08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.00 ± 1.00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.67 ± 1.53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67 ± 0.58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.67</a:t>
                      </a:r>
                      <a:r>
                        <a:rPr lang="en-US" altLang="ko-KR" sz="12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*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± 39.27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68367">
                <a:tc>
                  <a:txBody>
                    <a:bodyPr/>
                    <a:lstStyle/>
                    <a:p>
                      <a:pPr marL="180340"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b="1" i="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CE/(PCE+NCE)</a:t>
                      </a:r>
                    </a:p>
                    <a:p>
                      <a:pPr marL="18034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(Mean</a:t>
                      </a:r>
                      <a:r>
                        <a:rPr lang="en-US" altLang="ko-KR" sz="10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000" b="1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± S.D)</a:t>
                      </a:r>
                      <a:endParaRPr lang="ko-KR" altLang="ko-KR" sz="1000" b="1" i="0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55 ± 0.13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59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0.0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62 ± 0.06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65 ± 0.06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44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0.02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68367">
                <a:tc>
                  <a:txBody>
                    <a:bodyPr/>
                    <a:lstStyle/>
                    <a:p>
                      <a:pPr marL="180340" marR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umber of animals</a:t>
                      </a:r>
                      <a:endParaRPr lang="ko-KR" altLang="ko-KR" sz="1200" b="1" i="0" kern="100" dirty="0" smtClean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4770" marR="64770" marT="17780" marB="1778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ko-KR" alt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ko-KR" sz="1200" kern="100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9525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95536" y="3140968"/>
            <a:ext cx="8064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MNPCE: PCE with one or more micronuclei; PCE: Polychromatic erythrocyte; NCE: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ormochromatic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erythrocyte</a:t>
            </a:r>
          </a:p>
          <a:p>
            <a:pPr>
              <a:lnSpc>
                <a:spcPct val="150000"/>
              </a:lnSpc>
            </a:pP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*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ignificantly different from the control at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&lt;0.05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821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7</TotalTime>
  <Words>987</Words>
  <Application>Microsoft Office PowerPoint</Application>
  <PresentationFormat>화면 슬라이드 쇼(4:3)</PresentationFormat>
  <Paragraphs>464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5" baseType="lpstr">
      <vt:lpstr>굴림</vt:lpstr>
      <vt:lpstr>돋움</vt:lpstr>
      <vt:lpstr>맑은 고딕</vt:lpstr>
      <vt:lpstr>바탕</vt:lpstr>
      <vt:lpstr>Arial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한국한의학연구원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이미영</dc:creator>
  <cp:lastModifiedBy>USER</cp:lastModifiedBy>
  <cp:revision>93</cp:revision>
  <cp:lastPrinted>2013-12-09T05:32:45Z</cp:lastPrinted>
  <dcterms:created xsi:type="dcterms:W3CDTF">2010-09-09T01:30:49Z</dcterms:created>
  <dcterms:modified xsi:type="dcterms:W3CDTF">2015-05-14T02:21:15Z</dcterms:modified>
</cp:coreProperties>
</file>